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73" r:id="rId2"/>
    <p:sldId id="265" r:id="rId3"/>
  </p:sldIdLst>
  <p:sldSz cx="12192000" cy="6858000"/>
  <p:notesSz cx="6858000" cy="9144000"/>
  <p:defaultTextStyle>
    <a:defPPr>
      <a:defRPr lang="en-CH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14" autoAdjust="0"/>
    <p:restoredTop sz="94660"/>
  </p:normalViewPr>
  <p:slideViewPr>
    <p:cSldViewPr snapToGrid="0">
      <p:cViewPr varScale="1">
        <p:scale>
          <a:sx n="76" d="100"/>
          <a:sy n="76" d="100"/>
        </p:scale>
        <p:origin x="720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H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C9CD8F8-24D2-4703-AB85-DE833007FB38}" type="datetimeFigureOut">
              <a:rPr lang="en-CH" smtClean="0"/>
              <a:t>07/11/2019</a:t>
            </a:fld>
            <a:endParaRPr lang="en-CH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H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C34FAAC-D318-45A1-B62E-0D0B050E2DA9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26192954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Video shows the dynamic/animated Poincaré plot for a dog at baseline (blue) and after treatment with hydromorphone (red). After the intravenous administration the dog calms and the heart rate continues to slow with the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arasympathomimetic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effects of the hydromorphone take effect. The pattern of the beat-to-beat intervals illustrate a pronounced pattern of long-short and short-long intervals with an additional cloud of long-long intervals. This video accompanies 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13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ee 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13 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egend for additional comments.</a:t>
            </a:r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8F8A442-7F39-43E8-AD5A-733AAF9B6ADB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189501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43AB1D-7A04-469C-B7AC-BBED4AD55BD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H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18D9162-4C02-4420-9040-611ECCE4749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DFA037-2797-4D8B-B7EB-3599205F9A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5EA24-3803-45B0-A1B6-0510A1E3A566}" type="datetimeFigureOut">
              <a:rPr lang="en-CH" smtClean="0"/>
              <a:t>07/11/2019</a:t>
            </a:fld>
            <a:endParaRPr lang="en-C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3C99E15-CE1C-48D1-BC0B-7096E9C392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571F7B-77B9-439D-847C-64F558A306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45655-AA60-4D73-B703-93CA29CAD1C8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38659344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B40032-CA07-4EA4-8921-54D064A65F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H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8EF805C-5A64-416B-A266-D9729C3564F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4806A0-AD54-479D-B1A1-4BC3188CDF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5EA24-3803-45B0-A1B6-0510A1E3A566}" type="datetimeFigureOut">
              <a:rPr lang="en-CH" smtClean="0"/>
              <a:t>07/11/2019</a:t>
            </a:fld>
            <a:endParaRPr lang="en-C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CD517C-CBB5-42DB-86BD-572B828E09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09B068-9134-4784-95E7-98EBF2E3C0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45655-AA60-4D73-B703-93CA29CAD1C8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15314771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19CF6C5-A4B1-45C4-B417-F03248D8A82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H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C71D680-9590-4497-8038-344072ED9D6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DC1B1C-F987-4CD2-8185-671ADC21D3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5EA24-3803-45B0-A1B6-0510A1E3A566}" type="datetimeFigureOut">
              <a:rPr lang="en-CH" smtClean="0"/>
              <a:t>07/11/2019</a:t>
            </a:fld>
            <a:endParaRPr lang="en-C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23033C-5E50-428D-84CE-5C55BB6CBA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9EE5B2-149F-4C24-8965-BA41734C4E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45655-AA60-4D73-B703-93CA29CAD1C8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27704257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FDA620-CF20-44A1-AA37-735207DDCC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9DE5FE2-70B5-48AC-BC06-7AABF3BD351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65DCEC-B272-490E-8FA8-0D37286DC6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5EA24-3803-45B0-A1B6-0510A1E3A566}" type="datetimeFigureOut">
              <a:rPr lang="en-CH" smtClean="0"/>
              <a:t>07/11/2019</a:t>
            </a:fld>
            <a:endParaRPr lang="en-C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676A92-2A67-457D-BA7C-6C3327F42C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FAAC00-5907-4FEF-B6A1-B82A1755A9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45655-AA60-4D73-B703-93CA29CAD1C8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41217830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C86FA9-E8C8-413A-8326-A5332D6A5A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C7DC88B-4A1E-4CED-8941-73CBDF6C4A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888478-105A-44BB-AA3E-18F35DA7D0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5EA24-3803-45B0-A1B6-0510A1E3A566}" type="datetimeFigureOut">
              <a:rPr lang="en-CH" smtClean="0"/>
              <a:t>07/11/2019</a:t>
            </a:fld>
            <a:endParaRPr lang="en-C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9EFA66-4DA4-4222-8747-B420774CCB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77CC2A-327D-4173-BC54-155ECB0943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45655-AA60-4D73-B703-93CA29CAD1C8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28637520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D3BAE8-253E-43E2-B479-9B3765F1BC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F83E9D4-5554-4CED-94C1-7AFFDB83142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H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BDF6C40-65B3-49D7-9A76-12CE20FD49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H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55C42D6-DF34-423E-A4B2-D5391D1C4A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5EA24-3803-45B0-A1B6-0510A1E3A566}" type="datetimeFigureOut">
              <a:rPr lang="en-CH" smtClean="0"/>
              <a:t>07/11/2019</a:t>
            </a:fld>
            <a:endParaRPr lang="en-C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F454E4E-F039-4C8B-8190-94B79DE5C0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473EFA1-968C-48D3-9774-5E6DFF393C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45655-AA60-4D73-B703-93CA29CAD1C8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8254465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003E95-2764-4B02-9C3F-7F83AE8052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F7E0D6D-87BA-435A-91B8-C4773D9DDF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5A445F6-BA36-405C-8E20-F01453A9216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H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465E1D3-1C22-441A-949F-19EBF29576E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41E4337-CE51-43EA-83F9-440FD82C802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H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D339D7E-7FA2-43D6-9FB2-3B45FB16BD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5EA24-3803-45B0-A1B6-0510A1E3A566}" type="datetimeFigureOut">
              <a:rPr lang="en-CH" smtClean="0"/>
              <a:t>07/11/2019</a:t>
            </a:fld>
            <a:endParaRPr lang="en-CH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A5E749C-12ED-4780-8509-7B04CBBA41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8705445-5EB4-475B-9CC8-A6ACA6C12D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45655-AA60-4D73-B703-93CA29CAD1C8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21649966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1F47EE-26CD-41CE-BC61-A5D9F83FDA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H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DAFFE2E-C0BC-4745-B954-2E3B4F5C52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5EA24-3803-45B0-A1B6-0510A1E3A566}" type="datetimeFigureOut">
              <a:rPr lang="en-CH" smtClean="0"/>
              <a:t>07/11/2019</a:t>
            </a:fld>
            <a:endParaRPr lang="en-CH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368076C-80B1-4BA3-8ED5-517F6D09A4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EB648EC-91A5-4A07-9FB8-5693634A9C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45655-AA60-4D73-B703-93CA29CAD1C8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34854348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05351B0-5655-441A-98F2-E8F541CE43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5EA24-3803-45B0-A1B6-0510A1E3A566}" type="datetimeFigureOut">
              <a:rPr lang="en-CH" smtClean="0"/>
              <a:t>07/11/2019</a:t>
            </a:fld>
            <a:endParaRPr lang="en-CH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F2990A8-D611-4E42-9D4D-890E978787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A11DB77-2451-4F90-A59C-44041A936A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45655-AA60-4D73-B703-93CA29CAD1C8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17197360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868B4A-1234-43E8-9C63-26E973B721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DACF42A-92DF-4324-B9DB-AD927425F28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H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BB4B591-1884-4B75-9988-24AC6B627F5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BF5A9A9-BD8C-48E3-94EC-4A2A8C9123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5EA24-3803-45B0-A1B6-0510A1E3A566}" type="datetimeFigureOut">
              <a:rPr lang="en-CH" smtClean="0"/>
              <a:t>07/11/2019</a:t>
            </a:fld>
            <a:endParaRPr lang="en-C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E18103A-52AA-43BC-A530-608E2CDF8A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3CA8789-EB40-4B82-AEA3-5ACC85BABF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45655-AA60-4D73-B703-93CA29CAD1C8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27380857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DE16DA-4013-4E71-920D-801BB1DCA6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H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27BC516-2435-446D-B95E-AFF94394E2E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H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C248595-4754-4390-B703-C410E6E3B22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C5C7B8D-32BF-4D69-862F-B3FC44A574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5EA24-3803-45B0-A1B6-0510A1E3A566}" type="datetimeFigureOut">
              <a:rPr lang="en-CH" smtClean="0"/>
              <a:t>07/11/2019</a:t>
            </a:fld>
            <a:endParaRPr lang="en-C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DA60CB-1782-4E68-B79C-7CE55242D6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4C5ED99-EC1B-4383-B1EB-2AAD9A4B88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45655-AA60-4D73-B703-93CA29CAD1C8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22640365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A49A163-EC90-4E21-A249-8A6190AFBF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A5A0A1-AFCF-485B-95BE-6F7B2EF4A6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185F67-3A89-45AE-BB05-4A8CE0D3106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45EA24-3803-45B0-A1B6-0510A1E3A566}" type="datetimeFigureOut">
              <a:rPr lang="en-CH" smtClean="0"/>
              <a:t>07/11/2019</a:t>
            </a:fld>
            <a:endParaRPr lang="en-C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11D506-006B-47D5-A70D-A95332EF8D2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C60022-5D83-47B6-BB3B-3DD8A3346A8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A45655-AA60-4D73-B703-93CA29CAD1C8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3641457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CH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5" Type="http://schemas.openxmlformats.org/officeDocument/2006/relationships/image" Target="../media/image1.png"/><Relationship Id="rId4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/>
        </p:nvGraphicFramePr>
        <p:xfrm>
          <a:off x="632638" y="1897911"/>
          <a:ext cx="10834577" cy="292608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454266">
                  <a:extLst>
                    <a:ext uri="{9D8B030D-6E8A-4147-A177-3AD203B41FA5}">
                      <a16:colId xmlns:a16="http://schemas.microsoft.com/office/drawing/2014/main" val="47727976"/>
                    </a:ext>
                  </a:extLst>
                </a:gridCol>
                <a:gridCol w="9380311">
                  <a:extLst>
                    <a:ext uri="{9D8B030D-6E8A-4147-A177-3AD203B41FA5}">
                      <a16:colId xmlns:a16="http://schemas.microsoft.com/office/drawing/2014/main" val="1452130862"/>
                    </a:ext>
                  </a:extLst>
                </a:gridCol>
              </a:tblGrid>
              <a:tr h="2464889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b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VIDEO 9</a:t>
                      </a:r>
                    </a:p>
                  </a:txBody>
                  <a:tcPr marL="68580" marR="68580" marT="0" marB="0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b="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Video shows the dynamic/animated Poincaré plot for a dog at baseline (blue) and after treatment with hydromorphone (red). After the intravenous injection the dog calms and the heart rate continues to slow with the </a:t>
                      </a:r>
                      <a:r>
                        <a:rPr lang="en-US" sz="2400" b="0" dirty="0" err="1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arasympathomimetic</a:t>
                      </a:r>
                      <a:r>
                        <a:rPr lang="en-US" sz="2400" b="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effects of the hydromorphone. The pattern of the beat-to-beat intervals illustrate a pronounced pattern of long-short and short-long intervals with an additional cloud of long-long intervals. This video accompanies Figure 13. See Figure 13 legend for additional comments.</a:t>
                      </a:r>
                    </a:p>
                  </a:txBody>
                  <a:tcPr marL="68580" marR="68580" marT="0" marB="0">
                    <a:solidFill>
                      <a:srgbClr val="0070C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5232271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927108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VIDEO 9 Moise_With Figure 13_09_25_2019 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3513114" y="742618"/>
            <a:ext cx="5054120" cy="4862063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27660" y="210751"/>
            <a:ext cx="2139021" cy="369332"/>
          </a:xfrm>
          <a:prstGeom prst="rect">
            <a:avLst/>
          </a:prstGeom>
          <a:noFill/>
          <a:ln>
            <a:solidFill>
              <a:srgbClr val="0000CC"/>
            </a:solidFill>
          </a:ln>
        </p:spPr>
        <p:txBody>
          <a:bodyPr wrap="square" rtlCol="0">
            <a:spAutoFit/>
          </a:bodyPr>
          <a:lstStyle/>
          <a:p>
            <a:r>
              <a:rPr lang="en-US" sz="1800" b="1" kern="1200" dirty="0">
                <a:solidFill>
                  <a:srgbClr val="FF0000"/>
                </a:solidFill>
                <a:latin typeface="+mn-lt"/>
                <a:ea typeface="+mn-ea"/>
                <a:cs typeface="+mn-cs"/>
              </a:rPr>
              <a:t>Video </a:t>
            </a:r>
            <a:r>
              <a:rPr lang="en-US" b="1" dirty="0">
                <a:solidFill>
                  <a:srgbClr val="FF0000"/>
                </a:solidFill>
              </a:rPr>
              <a:t>9</a:t>
            </a:r>
            <a:r>
              <a:rPr lang="en-US" sz="1800" b="1" kern="1200" dirty="0">
                <a:solidFill>
                  <a:srgbClr val="FF0000"/>
                </a:solidFill>
                <a:latin typeface="+mn-lt"/>
                <a:ea typeface="+mn-ea"/>
                <a:cs typeface="+mn-cs"/>
              </a:rPr>
              <a:t> (Figure 13)</a:t>
            </a:r>
          </a:p>
        </p:txBody>
      </p:sp>
      <p:cxnSp>
        <p:nvCxnSpPr>
          <p:cNvPr id="4" name="Straight Arrow Connector 3"/>
          <p:cNvCxnSpPr/>
          <p:nvPr/>
        </p:nvCxnSpPr>
        <p:spPr>
          <a:xfrm flipV="1">
            <a:off x="7497464" y="1106396"/>
            <a:ext cx="370545" cy="1170"/>
          </a:xfrm>
          <a:prstGeom prst="straightConnector1">
            <a:avLst/>
          </a:prstGeom>
          <a:ln w="15875">
            <a:solidFill>
              <a:srgbClr val="C00000"/>
            </a:solidFill>
            <a:headEnd type="oval" w="med" len="med"/>
            <a:tailEnd type="oval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Arrow Connector 4"/>
          <p:cNvCxnSpPr/>
          <p:nvPr/>
        </p:nvCxnSpPr>
        <p:spPr>
          <a:xfrm flipV="1">
            <a:off x="7497464" y="1487223"/>
            <a:ext cx="374904" cy="1171"/>
          </a:xfrm>
          <a:prstGeom prst="straightConnector1">
            <a:avLst/>
          </a:prstGeom>
          <a:ln w="15875">
            <a:solidFill>
              <a:srgbClr val="0000CC"/>
            </a:solidFill>
            <a:headEnd type="oval" w="med" len="med"/>
            <a:tailEnd type="oval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7943098" y="1247047"/>
            <a:ext cx="1196461" cy="43088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2200" dirty="0">
                <a:solidFill>
                  <a:srgbClr val="0000CC"/>
                </a:solidFill>
              </a:rPr>
              <a:t>Baseline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7943098" y="904925"/>
            <a:ext cx="214714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dirty="0">
                <a:solidFill>
                  <a:srgbClr val="C00000"/>
                </a:solidFill>
              </a:rPr>
              <a:t>Hydromorphone</a:t>
            </a:r>
          </a:p>
        </p:txBody>
      </p:sp>
      <p:sp>
        <p:nvSpPr>
          <p:cNvPr id="8" name="TextBox 7"/>
          <p:cNvSpPr txBox="1"/>
          <p:nvPr/>
        </p:nvSpPr>
        <p:spPr>
          <a:xfrm rot="10800000" flipV="1">
            <a:off x="4922389" y="5564268"/>
            <a:ext cx="22543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R-R Interval (ms)</a:t>
            </a:r>
          </a:p>
        </p:txBody>
      </p:sp>
      <p:sp>
        <p:nvSpPr>
          <p:cNvPr id="9" name="TextBox 8"/>
          <p:cNvSpPr txBox="1"/>
          <p:nvPr/>
        </p:nvSpPr>
        <p:spPr>
          <a:xfrm rot="16200000">
            <a:off x="1850508" y="2820577"/>
            <a:ext cx="270157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R-R + 1 Interval (ms)</a:t>
            </a:r>
          </a:p>
        </p:txBody>
      </p:sp>
    </p:spTree>
    <p:extLst>
      <p:ext uri="{BB962C8B-B14F-4D97-AF65-F5344CB8AC3E}">
        <p14:creationId xmlns:p14="http://schemas.microsoft.com/office/powerpoint/2010/main" val="426440348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1</Words>
  <Application>Microsoft Office PowerPoint</Application>
  <PresentationFormat>Widescreen</PresentationFormat>
  <Paragraphs>9</Paragraphs>
  <Slides>2</Slides>
  <Notes>1</Notes>
  <HiddenSlides>0</HiddenSlides>
  <MMClips>1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tin Des Crescenzio</dc:creator>
  <cp:lastModifiedBy>Martin Des Crescenzio</cp:lastModifiedBy>
  <cp:revision>1</cp:revision>
  <dcterms:created xsi:type="dcterms:W3CDTF">2019-11-07T15:43:36Z</dcterms:created>
  <dcterms:modified xsi:type="dcterms:W3CDTF">2019-11-07T15:43:55Z</dcterms:modified>
</cp:coreProperties>
</file>